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913" autoAdjust="0"/>
    <p:restoredTop sz="94660"/>
  </p:normalViewPr>
  <p:slideViewPr>
    <p:cSldViewPr snapToGrid="0">
      <p:cViewPr varScale="1">
        <p:scale>
          <a:sx n="43" d="100"/>
          <a:sy n="43" d="100"/>
        </p:scale>
        <p:origin x="37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272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789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17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04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385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207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61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2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35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76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07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A9AF89-5AC9-447D-98CA-A20740CF3A7B}" type="datetimeFigureOut">
              <a:rPr lang="en-US" smtClean="0"/>
              <a:t>1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55C08-9CCB-4A8E-8FC8-9EECF72BA3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14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lf9_kir_video">
            <a:hlinkClick r:id="" action="ppaction://media"/>
            <a:extLst>
              <a:ext uri="{FF2B5EF4-FFF2-40B4-BE49-F238E27FC236}">
                <a16:creationId xmlns:a16="http://schemas.microsoft.com/office/drawing/2014/main" id="{666B25B1-6A50-4BB3-B382-784AC9DFA6E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72427" y="1209619"/>
            <a:ext cx="4957395" cy="437832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3E438A7-FBFB-403D-BA67-7D378F3663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5619" y="1201381"/>
            <a:ext cx="4089555" cy="21725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D44F552-E42F-4127-A44F-B80C71890BD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4" r="5104"/>
          <a:stretch/>
        </p:blipFill>
        <p:spPr>
          <a:xfrm>
            <a:off x="6365619" y="3415367"/>
            <a:ext cx="4089555" cy="217257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56B4D5-73E2-4392-9EB0-8D38ABEE02C1}"/>
              </a:ext>
            </a:extLst>
          </p:cNvPr>
          <p:cNvSpPr txBox="1"/>
          <p:nvPr/>
        </p:nvSpPr>
        <p:spPr>
          <a:xfrm>
            <a:off x="1372427" y="123913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C520C68-D5F7-4BF4-8CA3-4E1BCCA06897}"/>
              </a:ext>
            </a:extLst>
          </p:cNvPr>
          <p:cNvSpPr txBox="1"/>
          <p:nvPr/>
        </p:nvSpPr>
        <p:spPr>
          <a:xfrm>
            <a:off x="6376176" y="123913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027390-1963-4F39-B2CE-295727F76C7C}"/>
              </a:ext>
            </a:extLst>
          </p:cNvPr>
          <p:cNvSpPr txBox="1"/>
          <p:nvPr/>
        </p:nvSpPr>
        <p:spPr>
          <a:xfrm>
            <a:off x="6363065" y="343907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BF5CCC-71A8-4DE1-9D08-B3F51A7ACAEB}"/>
              </a:ext>
            </a:extLst>
          </p:cNvPr>
          <p:cNvSpPr/>
          <p:nvPr/>
        </p:nvSpPr>
        <p:spPr>
          <a:xfrm>
            <a:off x="1122947" y="6016974"/>
            <a:ext cx="10010274" cy="21828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9. 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of the potential interference of FLX with HLA/killer cell immunoglobulin-like receptor (KIR)-3DL on NK cells. 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 (PDB ID: 2YPK) /KIR-3DL (PDB ID: 3VH8) interaction showing the spatial proximity of HLA-K146 and the P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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of the peptide and their location on the contact area among HLA and KIR (click on video play)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X-conjugated in K146 residue in HLA molecule. HLA pocket is occupied by KAF11 peptide (PDB ID:2YPK)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X-TAA_K9 peptide in the HLA pocket. In all the figures, HLA is represented in gray, KIR-3DL in teal, peptides are in blue, the HLA-K146 residue is in yellow, and the P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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 residue of the peptide is shown in white. FLX is represented in red. 3-D structures were visualized in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MO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.</a:t>
            </a:r>
          </a:p>
          <a:p>
            <a:pPr algn="just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61143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00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173</Words>
  <Application>Microsoft Office PowerPoint</Application>
  <PresentationFormat>Custom</PresentationFormat>
  <Paragraphs>4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ig, Montserrat</dc:creator>
  <cp:lastModifiedBy>Puig, Montserrat</cp:lastModifiedBy>
  <cp:revision>19</cp:revision>
  <dcterms:created xsi:type="dcterms:W3CDTF">2020-11-13T13:19:48Z</dcterms:created>
  <dcterms:modified xsi:type="dcterms:W3CDTF">2021-01-22T21:25:39Z</dcterms:modified>
</cp:coreProperties>
</file>